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3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146444-644B-1A44-46FB-299D82F01238}"/>
              </a:ext>
            </a:extLst>
          </p:cNvPr>
          <p:cNvSpPr txBox="1"/>
          <p:nvPr/>
        </p:nvSpPr>
        <p:spPr>
          <a:xfrm>
            <a:off x="127533" y="4691582"/>
            <a:ext cx="659892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14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The </a:t>
            </a:r>
            <a:r>
              <a:rPr lang="en-US" sz="11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C32 </a:t>
            </a:r>
            <a:r>
              <a:rPr lang="en-US" sz="1100" b="1" kern="100" dirty="0" err="1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wS</a:t>
            </a:r>
            <a:r>
              <a:rPr lang="en-US" sz="11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cell line demonstrates increased sensitivity to radiation therapy compared to the A673 cell line in vitro.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wing cell lines (A673, TC32) were treated with radiation (2Gy or 5Gy) vs an unirradiated control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ive-cell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ncuCyt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onitoring of cell confluence and apoptosis (caspase 3/7 activity) was monitored. The graph displays the relative apoptosis (apoptosis/confluence) between TC32 cell line treated with radiation therapy versus A673 cells treated with radiation (left panel). The right panel shows only A673 cells.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*** = p-value &lt;0.00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eriments completed minimally in biological triplicate. Error bars denote S.D.</a:t>
            </a:r>
            <a:endParaRPr lang="en-US" sz="11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6B7A2A5-1045-3EB1-80FE-979FF1481B8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816" r="6664"/>
          <a:stretch/>
        </p:blipFill>
        <p:spPr bwMode="auto">
          <a:xfrm>
            <a:off x="196130" y="1880427"/>
            <a:ext cx="6278965" cy="236310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Right Brace 3">
            <a:extLst>
              <a:ext uri="{FF2B5EF4-FFF2-40B4-BE49-F238E27FC236}">
                <a16:creationId xmlns:a16="http://schemas.microsoft.com/office/drawing/2014/main" id="{EE6228D2-9E24-67B3-4463-E15B4AC83C60}"/>
              </a:ext>
            </a:extLst>
          </p:cNvPr>
          <p:cNvSpPr/>
          <p:nvPr/>
        </p:nvSpPr>
        <p:spPr>
          <a:xfrm>
            <a:off x="3045350" y="2329731"/>
            <a:ext cx="45719" cy="1073427"/>
          </a:xfrm>
          <a:prstGeom prst="rightBrac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B4A9661-BAC8-8A08-F31A-DA6B4F3C72A9}"/>
              </a:ext>
            </a:extLst>
          </p:cNvPr>
          <p:cNvSpPr txBox="1"/>
          <p:nvPr/>
        </p:nvSpPr>
        <p:spPr>
          <a:xfrm rot="5400000">
            <a:off x="2824700" y="2681778"/>
            <a:ext cx="532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3417336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1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1:59Z</dcterms:modified>
</cp:coreProperties>
</file>